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olynn C Arpin" initials="CCA" lastIdx="1" clrIdx="0">
    <p:extLst>
      <p:ext uri="{19B8F6BF-5375-455C-9EA6-DF929625EA0E}">
        <p15:presenceInfo xmlns:p15="http://schemas.microsoft.com/office/powerpoint/2012/main" userId="S-1-5-21-120921916-498163275-930774774-4633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824"/>
    <p:restoredTop sz="72739" autoAdjust="0"/>
  </p:normalViewPr>
  <p:slideViewPr>
    <p:cSldViewPr snapToGrid="0" snapToObjects="1">
      <p:cViewPr varScale="1">
        <p:scale>
          <a:sx n="52" d="100"/>
          <a:sy n="52" d="100"/>
        </p:scale>
        <p:origin x="179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7DF869-0721-9646-830D-3D8A79DE7D53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86E5D7-8D96-434C-B74A-59F4BC99D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3845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1 Table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quilibrium dissociation constants (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values as measured by SPR, which were used to assess binding affinity between compounds and the GRB2 protein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9717B71-559E-E745-9FE3-89CF17EC7B20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218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439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432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724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90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207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570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138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222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232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147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0233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2BCF69-5755-C445-8276-CBEBD5F69EC5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19D40B-8878-0D4F-ACF4-BC361AF50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0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2516244"/>
              </p:ext>
            </p:extLst>
          </p:nvPr>
        </p:nvGraphicFramePr>
        <p:xfrm>
          <a:off x="1991360" y="1971040"/>
          <a:ext cx="5049348" cy="324323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2044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449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64864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Compound</a:t>
                      </a:r>
                      <a:endParaRPr lang="en-US" sz="20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i="1" dirty="0">
                          <a:effectLst/>
                        </a:rPr>
                        <a:t>K</a:t>
                      </a:r>
                      <a:r>
                        <a:rPr lang="en-US" sz="2000" baseline="-25000" dirty="0">
                          <a:effectLst/>
                        </a:rPr>
                        <a:t>D</a:t>
                      </a:r>
                      <a:endParaRPr lang="en-US" sz="20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51435" marR="51435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4864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NHD2-15</a:t>
                      </a:r>
                      <a:endParaRPr lang="en-US" sz="20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119 ± 2 µM</a:t>
                      </a:r>
                      <a:endParaRPr lang="en-US" sz="20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51435" marR="51435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4864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NHD2-92</a:t>
                      </a:r>
                      <a:endParaRPr lang="en-US" sz="20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1000 ± 20 µM*</a:t>
                      </a:r>
                      <a:endParaRPr lang="en-US" sz="20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51435" marR="51435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4864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NHD2-107</a:t>
                      </a:r>
                      <a:endParaRPr lang="en-US" sz="20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3400 ± 100 µM*</a:t>
                      </a:r>
                      <a:endParaRPr lang="en-US" sz="20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51435" marR="51435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4864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</a:rPr>
                        <a:t>NHD2-114</a:t>
                      </a:r>
                      <a:endParaRPr lang="en-US" sz="20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440 ± 7 µM*</a:t>
                      </a:r>
                      <a:endParaRPr lang="en-US" sz="20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51435" marR="51435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0" y="6557918"/>
            <a:ext cx="76424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/>
              <a:t>S1 Tabl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DD5BF4D-4FA4-465D-8461-C31FCC5F13BA}"/>
              </a:ext>
            </a:extLst>
          </p:cNvPr>
          <p:cNvSpPr txBox="1"/>
          <p:nvPr/>
        </p:nvSpPr>
        <p:spPr>
          <a:xfrm>
            <a:off x="1991361" y="5214275"/>
            <a:ext cx="504934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SPR data was sub-optimal for these compounds.  See </a:t>
            </a:r>
            <a:r>
              <a:rPr lang="en-US" sz="1400" b="1" dirty="0"/>
              <a:t>Supporting Information</a:t>
            </a:r>
            <a:r>
              <a:rPr lang="en-US" sz="1400" dirty="0"/>
              <a:t> S4-S11 Figs for raw </a:t>
            </a:r>
            <a:r>
              <a:rPr lang="en-US" sz="1400" dirty="0" err="1"/>
              <a:t>sensorgrams</a:t>
            </a:r>
            <a:r>
              <a:rPr lang="en-US" sz="1400" dirty="0"/>
              <a:t> and dose-response curves.</a:t>
            </a:r>
          </a:p>
        </p:txBody>
      </p:sp>
    </p:spTree>
    <p:extLst>
      <p:ext uri="{BB962C8B-B14F-4D97-AF65-F5344CB8AC3E}">
        <p14:creationId xmlns:p14="http://schemas.microsoft.com/office/powerpoint/2010/main" val="29994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39</TotalTime>
  <Words>78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CSU Chic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Stachura</dc:creator>
  <cp:lastModifiedBy>chn off32</cp:lastModifiedBy>
  <cp:revision>57</cp:revision>
  <dcterms:created xsi:type="dcterms:W3CDTF">2019-04-23T20:35:17Z</dcterms:created>
  <dcterms:modified xsi:type="dcterms:W3CDTF">2020-08-04T03:47:33Z</dcterms:modified>
</cp:coreProperties>
</file>